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2214" y="107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8D74F-E63F-4C04-9E03-CABAB57C273A}" type="datetimeFigureOut">
              <a:rPr kumimoji="1" lang="ja-JP" altLang="en-US" smtClean="0"/>
              <a:pPr/>
              <a:t>2012/3/1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2CDD35-67D6-4CE8-827F-A9CC1840860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730195" y="632520"/>
            <a:ext cx="5400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Figure S4. Cumulative death rates for primary site-specific cancer deaths among two lipoprotein(a) [Lp(a)] groups.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30195" y="7905328"/>
            <a:ext cx="540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/>
              <a:t>The cumulative death rate of the low Lp(a) group [Lp(a) &lt; 80 mg/L] is significantly higher than that of the intermediate-to-high Lp(a) group [Lp(a) ≥ 80 mg/L] in liver cancer and noncancerous causes.</a:t>
            </a:r>
          </a:p>
        </p:txBody>
      </p:sp>
      <p:pic>
        <p:nvPicPr>
          <p:cNvPr id="142" name="図 141" descr="FigS3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30195" y="1352600"/>
            <a:ext cx="5397610" cy="645247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62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otoji Sawabe</dc:creator>
  <cp:lastModifiedBy>Motoji Sawabe</cp:lastModifiedBy>
  <cp:revision>45</cp:revision>
  <dcterms:created xsi:type="dcterms:W3CDTF">2011-09-12T07:35:12Z</dcterms:created>
  <dcterms:modified xsi:type="dcterms:W3CDTF">2012-03-11T06:20:28Z</dcterms:modified>
</cp:coreProperties>
</file>